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2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CD44</a:t>
            </a:r>
            <a:r>
              <a:rPr lang="en-GB" sz="1600" dirty="0" smtClean="0"/>
              <a:t> gene. A) Wild (Template</a:t>
            </a:r>
            <a:r>
              <a:rPr lang="en-US" sz="1600" dirty="0" smtClean="0"/>
              <a:t> 4pz3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4pz3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00100" y="785794"/>
            <a:ext cx="2414604" cy="20717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6381" y="114300"/>
            <a:ext cx="2928957" cy="302894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000100" y="3643314"/>
            <a:ext cx="2444664" cy="22145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357818" y="3286124"/>
            <a:ext cx="2857520" cy="271464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6</cp:revision>
  <dcterms:created xsi:type="dcterms:W3CDTF">2018-05-10T07:33:24Z</dcterms:created>
  <dcterms:modified xsi:type="dcterms:W3CDTF">2018-05-29T06:53:25Z</dcterms:modified>
</cp:coreProperties>
</file>